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105" d="100"/>
          <a:sy n="105" d="100"/>
        </p:scale>
        <p:origin x="96" y="12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C6C5948-3AAB-F8EC-BDAE-13A1B1F0497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39FEEA31-2460-4EDF-DBD4-93F6405A6DA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43063C7-0462-52B3-896A-8ECAE49E6A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B86B90-FF08-4A79-9D2F-FBD39DFE3A0B}" type="datetimeFigureOut">
              <a:rPr lang="zh-CN" altLang="en-US" smtClean="0"/>
              <a:t>2024/8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802C16E-1C02-C47C-04D2-01FEE60A97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495A6E9-EC63-4CF1-7C9E-DC71BC0BCC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08C41-D72F-42ED-A048-A6366FE7E4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782862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2BEFE62-2AB8-1520-3241-A69FF042F8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DB3381A-4D44-3DAF-D9F7-D6BDDF515EB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653D755-2087-CA17-C79F-57B8F55107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B86B90-FF08-4A79-9D2F-FBD39DFE3A0B}" type="datetimeFigureOut">
              <a:rPr lang="zh-CN" altLang="en-US" smtClean="0"/>
              <a:t>2024/8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2BC369C-9C5E-7476-C444-D26E85800B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828FC07-CA07-A94B-1EB0-D890B1C12E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08C41-D72F-42ED-A048-A6366FE7E4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546239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11EC7918-A74B-76F5-0B04-766B4F00037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4338B11-6E9D-C312-175C-A9C2BB05659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7783478-F036-6A49-840F-012C62EEE6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B86B90-FF08-4A79-9D2F-FBD39DFE3A0B}" type="datetimeFigureOut">
              <a:rPr lang="zh-CN" altLang="en-US" smtClean="0"/>
              <a:t>2024/8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2388A1C-A4BC-2675-3995-C6B6DD201A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43A4176-4C29-D477-5763-EC0753FFE5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08C41-D72F-42ED-A048-A6366FE7E4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34039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D4A1493-D8C6-84D8-3E06-D954E9CAFE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7132CDC-D82A-E45A-8086-FC15CF283F8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72A74F7-043F-8623-E999-DA651CB0C2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B86B90-FF08-4A79-9D2F-FBD39DFE3A0B}" type="datetimeFigureOut">
              <a:rPr lang="zh-CN" altLang="en-US" smtClean="0"/>
              <a:t>2024/8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6923FC8-322A-6478-E09C-76C826379C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F3C507A-35A0-C92F-575E-347EB910DF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08C41-D72F-42ED-A048-A6366FE7E4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041024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D3A55D8-549C-6072-7381-F480510A76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AD4F259-4697-8DA8-5CEF-699214C1D2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AA7998B-D2D6-8BFE-B48F-54E9F00EF3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B86B90-FF08-4A79-9D2F-FBD39DFE3A0B}" type="datetimeFigureOut">
              <a:rPr lang="zh-CN" altLang="en-US" smtClean="0"/>
              <a:t>2024/8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FA57DC0-2C33-19A5-A189-E8339D390A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EE53417-D250-377C-1FFB-D134481862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08C41-D72F-42ED-A048-A6366FE7E4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395433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49F3E98-5D3D-EA26-A137-B577017FE9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8C529CC-FEFF-77A8-6924-43D3BA9FEBE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D490D34-B143-D3BC-E0A6-8ECD750B1F1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91748B1-9E06-7D9A-454B-D46950547B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B86B90-FF08-4A79-9D2F-FBD39DFE3A0B}" type="datetimeFigureOut">
              <a:rPr lang="zh-CN" altLang="en-US" smtClean="0"/>
              <a:t>2024/8/1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5901E7D-A71B-91D8-0CED-3C71E2D980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5BABAF3-7A44-F263-8041-B1A62BE28D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08C41-D72F-42ED-A048-A6366FE7E4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837677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C358403-0C2F-0315-BE64-F013E673EF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0B48483-3D72-3EED-B538-725C854D3C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7CD276E-01D8-5A0A-C5EF-DFF52DB1DC2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DD7F42C8-2EC6-46EF-FF9E-F79FBECC4EC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1C7FE682-DDB9-D8CD-10D5-807BB7D8963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AB033989-E1CE-F276-A869-9EACD4F7B9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B86B90-FF08-4A79-9D2F-FBD39DFE3A0B}" type="datetimeFigureOut">
              <a:rPr lang="zh-CN" altLang="en-US" smtClean="0"/>
              <a:t>2024/8/1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FA088F2C-69A7-4AB8-0063-97B6447E49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C8EA50B3-3201-38B4-C180-C877C0BD6D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08C41-D72F-42ED-A048-A6366FE7E4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970998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A3E679B-1CF8-4D4B-0174-95DDF368D4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BF2046DD-916D-5714-AC5F-7B1944CED9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B86B90-FF08-4A79-9D2F-FBD39DFE3A0B}" type="datetimeFigureOut">
              <a:rPr lang="zh-CN" altLang="en-US" smtClean="0"/>
              <a:t>2024/8/1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6938801F-5449-A89E-045B-98470FF832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3F065D3C-7C87-020B-FAF8-0FAC5AF96B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08C41-D72F-42ED-A048-A6366FE7E4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189352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31578B0F-CA1D-6EDA-7744-6052F6E8DE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B86B90-FF08-4A79-9D2F-FBD39DFE3A0B}" type="datetimeFigureOut">
              <a:rPr lang="zh-CN" altLang="en-US" smtClean="0"/>
              <a:t>2024/8/1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93210F94-3FC1-9D42-92C1-57923741EA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29CAEBBB-F0C4-AC15-9E23-C9FB295538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08C41-D72F-42ED-A048-A6366FE7E4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51858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020849E-E899-4F98-163B-E3B8F77FD1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EFCF680-BE81-34C6-3F8C-F75A9B95EF2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6556431-F97A-A1E4-26A0-E107790F5A5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985CB04-C1E5-3ECC-034D-EFFFA97C3B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B86B90-FF08-4A79-9D2F-FBD39DFE3A0B}" type="datetimeFigureOut">
              <a:rPr lang="zh-CN" altLang="en-US" smtClean="0"/>
              <a:t>2024/8/1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30CB2E2-3A46-AAE4-DEC1-8D88B5A916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8BBD57C-12C1-6176-8807-3FA65661C3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08C41-D72F-42ED-A048-A6366FE7E4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57480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BC2B366-B2C3-ECB9-D616-6E8CA17A78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8F030E78-7C6C-7C04-D2F8-DC4CD7A374C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7638FDF2-53F2-2B12-3728-477518A5C22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E38CBA1-97C5-3705-34BA-0BBBE72120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B86B90-FF08-4A79-9D2F-FBD39DFE3A0B}" type="datetimeFigureOut">
              <a:rPr lang="zh-CN" altLang="en-US" smtClean="0"/>
              <a:t>2024/8/1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41E0CCE-E92C-88D3-F563-D321E45783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A16EF75-3776-3719-7812-8A31AB65C0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08C41-D72F-42ED-A048-A6366FE7E4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057060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A17CDB27-1637-2F38-82FD-2391A17E39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4C44C3D-0414-0AC2-2882-2D30BBA9DA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D7EBA1D-50EA-3F96-2FE9-DEED7B23C88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B86B90-FF08-4A79-9D2F-FBD39DFE3A0B}" type="datetimeFigureOut">
              <a:rPr lang="zh-CN" altLang="en-US" smtClean="0"/>
              <a:t>2024/8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E236620-6CAA-A426-1CD0-C7C959A7E05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348B5C2-1E6A-8D77-10CA-587A0F3E847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508C41-D72F-42ED-A048-A6366FE7E4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90211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71F32DC1-5D1D-2D44-AE19-37FEC958394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50347" y="1097954"/>
            <a:ext cx="2566619" cy="3524824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7E1AE4A8-7EB8-CC29-E774-274D43D5CEE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3140059" y="1097954"/>
            <a:ext cx="2566619" cy="3524824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948E7CCE-BF40-3B52-C0D1-423CE3F0B6C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95203" y="1097954"/>
            <a:ext cx="2566619" cy="3524824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FCC66ABA-A7B9-9517-C062-E0C077C06A8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4914" y="1097954"/>
            <a:ext cx="2566619" cy="3524824"/>
          </a:xfrm>
          <a:prstGeom prst="rect">
            <a:avLst/>
          </a:prstGeom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109CCBB8-B13C-A053-549E-94A512E986D8}"/>
              </a:ext>
            </a:extLst>
          </p:cNvPr>
          <p:cNvSpPr txBox="1"/>
          <p:nvPr/>
        </p:nvSpPr>
        <p:spPr>
          <a:xfrm>
            <a:off x="478894" y="4692124"/>
            <a:ext cx="233595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nti-phospho-p44/42 MAPK antibody</a:t>
            </a:r>
            <a:endParaRPr lang="zh-CN" altLang="en-US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02F2A6C6-A970-9418-5B68-FDE47CBD6560}"/>
              </a:ext>
            </a:extLst>
          </p:cNvPr>
          <p:cNvSpPr txBox="1"/>
          <p:nvPr/>
        </p:nvSpPr>
        <p:spPr>
          <a:xfrm>
            <a:off x="3148459" y="4692124"/>
            <a:ext cx="2649125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anti-p44/42 MAPK antibody </a:t>
            </a:r>
            <a:endParaRPr lang="zh-CN" altLang="en-US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1641F70D-4FA0-C749-B9D8-328B697C4590}"/>
              </a:ext>
            </a:extLst>
          </p:cNvPr>
          <p:cNvSpPr txBox="1"/>
          <p:nvPr/>
        </p:nvSpPr>
        <p:spPr>
          <a:xfrm>
            <a:off x="5816386" y="4692124"/>
            <a:ext cx="2431849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anti-ERK1/2 MAPK antibody </a:t>
            </a:r>
            <a:endParaRPr lang="zh-CN" altLang="en-US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005331D6-D176-1525-B855-4FB8116DA212}"/>
              </a:ext>
            </a:extLst>
          </p:cNvPr>
          <p:cNvSpPr txBox="1"/>
          <p:nvPr/>
        </p:nvSpPr>
        <p:spPr>
          <a:xfrm>
            <a:off x="478894" y="2021284"/>
            <a:ext cx="168507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dirty="0">
                <a:solidFill>
                  <a:srgbClr val="FF0000"/>
                </a:solidFill>
              </a:rPr>
              <a:t>Ladder  Guy11  </a:t>
            </a:r>
            <a:r>
              <a:rPr lang="el-GR" altLang="zh-CN" sz="1100" dirty="0">
                <a:solidFill>
                  <a:srgbClr val="FF0000"/>
                </a:solidFill>
              </a:rPr>
              <a:t>Δ</a:t>
            </a:r>
            <a:r>
              <a:rPr lang="en-US" altLang="zh-CN" sz="1100" dirty="0">
                <a:solidFill>
                  <a:srgbClr val="FF0000"/>
                </a:solidFill>
              </a:rPr>
              <a:t>monsr1</a:t>
            </a:r>
            <a:endParaRPr lang="zh-CN" altLang="en-US" sz="1100" dirty="0">
              <a:solidFill>
                <a:srgbClr val="FF0000"/>
              </a:solidFill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0CB08918-9BEB-0D15-B5DB-9A0C3E626F87}"/>
              </a:ext>
            </a:extLst>
          </p:cNvPr>
          <p:cNvSpPr txBox="1"/>
          <p:nvPr/>
        </p:nvSpPr>
        <p:spPr>
          <a:xfrm>
            <a:off x="9040197" y="1610510"/>
            <a:ext cx="168507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dirty="0">
                <a:solidFill>
                  <a:srgbClr val="FF0000"/>
                </a:solidFill>
              </a:rPr>
              <a:t>Ladder  Guy11  </a:t>
            </a:r>
            <a:r>
              <a:rPr lang="el-GR" altLang="zh-CN" sz="1100" dirty="0">
                <a:solidFill>
                  <a:srgbClr val="FF0000"/>
                </a:solidFill>
              </a:rPr>
              <a:t>Δ</a:t>
            </a:r>
            <a:r>
              <a:rPr lang="en-US" altLang="zh-CN" sz="1100" dirty="0">
                <a:solidFill>
                  <a:srgbClr val="FF0000"/>
                </a:solidFill>
              </a:rPr>
              <a:t>monsr1</a:t>
            </a:r>
            <a:endParaRPr lang="zh-CN" altLang="en-US" sz="1100" dirty="0">
              <a:solidFill>
                <a:srgbClr val="FF0000"/>
              </a:solidFill>
            </a:endParaRPr>
          </a:p>
        </p:txBody>
      </p:sp>
      <p:sp>
        <p:nvSpPr>
          <p:cNvPr id="23" name="文本框 19">
            <a:extLst>
              <a:ext uri="{FF2B5EF4-FFF2-40B4-BE49-F238E27FC236}">
                <a16:creationId xmlns:a16="http://schemas.microsoft.com/office/drawing/2014/main" id="{005331D6-D176-1525-B855-4FB8116DA212}"/>
              </a:ext>
            </a:extLst>
          </p:cNvPr>
          <p:cNvSpPr txBox="1"/>
          <p:nvPr/>
        </p:nvSpPr>
        <p:spPr>
          <a:xfrm>
            <a:off x="6189773" y="1459120"/>
            <a:ext cx="168507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 dirty="0">
                <a:solidFill>
                  <a:srgbClr val="FF0000"/>
                </a:solidFill>
              </a:rPr>
              <a:t>Guy11  </a:t>
            </a:r>
            <a:r>
              <a:rPr lang="el-GR" altLang="zh-CN" sz="1100" dirty="0">
                <a:solidFill>
                  <a:srgbClr val="FF0000"/>
                </a:solidFill>
              </a:rPr>
              <a:t>Δ</a:t>
            </a:r>
            <a:r>
              <a:rPr lang="en-US" altLang="zh-CN" sz="1100" dirty="0">
                <a:solidFill>
                  <a:srgbClr val="FF0000"/>
                </a:solidFill>
              </a:rPr>
              <a:t>monsr1  Ladder</a:t>
            </a:r>
            <a:endParaRPr lang="zh-CN" altLang="en-US" sz="1100" dirty="0">
              <a:solidFill>
                <a:srgbClr val="FF0000"/>
              </a:solidFill>
            </a:endParaRPr>
          </a:p>
        </p:txBody>
      </p:sp>
      <p:sp>
        <p:nvSpPr>
          <p:cNvPr id="24" name="文本框 19">
            <a:extLst>
              <a:ext uri="{FF2B5EF4-FFF2-40B4-BE49-F238E27FC236}">
                <a16:creationId xmlns:a16="http://schemas.microsoft.com/office/drawing/2014/main" id="{005331D6-D176-1525-B855-4FB8116DA212}"/>
              </a:ext>
            </a:extLst>
          </p:cNvPr>
          <p:cNvSpPr txBox="1"/>
          <p:nvPr/>
        </p:nvSpPr>
        <p:spPr>
          <a:xfrm>
            <a:off x="4071312" y="2433250"/>
            <a:ext cx="168507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 dirty="0">
                <a:solidFill>
                  <a:srgbClr val="FF0000"/>
                </a:solidFill>
              </a:rPr>
              <a:t>Guy11  </a:t>
            </a:r>
            <a:r>
              <a:rPr lang="el-GR" altLang="zh-CN" sz="1100" dirty="0">
                <a:solidFill>
                  <a:srgbClr val="FF0000"/>
                </a:solidFill>
              </a:rPr>
              <a:t>Δ</a:t>
            </a:r>
            <a:r>
              <a:rPr lang="en-US" altLang="zh-CN" sz="1100" dirty="0">
                <a:solidFill>
                  <a:srgbClr val="FF0000"/>
                </a:solidFill>
              </a:rPr>
              <a:t>monsr1  Ladder</a:t>
            </a:r>
            <a:endParaRPr lang="zh-CN" altLang="en-US" sz="1100" dirty="0">
              <a:solidFill>
                <a:srgbClr val="FF0000"/>
              </a:solidFill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ADDEB797-FE2A-A911-A414-F454B3A6A8B3}"/>
              </a:ext>
            </a:extLst>
          </p:cNvPr>
          <p:cNvSpPr txBox="1"/>
          <p:nvPr/>
        </p:nvSpPr>
        <p:spPr>
          <a:xfrm>
            <a:off x="8450347" y="4673669"/>
            <a:ext cx="2495928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Anti-GAPDH Monoclonal Antibody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8819353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1</TotalTime>
  <Words>28</Words>
  <Application>Microsoft Office PowerPoint</Application>
  <PresentationFormat>宽屏</PresentationFormat>
  <Paragraphs>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ZHEN ZHANG</dc:creator>
  <cp:lastModifiedBy>ZHEN ZHANG</cp:lastModifiedBy>
  <cp:revision>1</cp:revision>
  <dcterms:created xsi:type="dcterms:W3CDTF">2024-08-17T12:30:08Z</dcterms:created>
  <dcterms:modified xsi:type="dcterms:W3CDTF">2024-08-17T13:31:36Z</dcterms:modified>
</cp:coreProperties>
</file>